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  <p:sldId id="259" r:id="rId4"/>
    <p:sldId id="260" r:id="rId5"/>
    <p:sldId id="261" r:id="rId6"/>
    <p:sldId id="262" r:id="rId7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9CB5B618-EFBB-43BC-8FE1-C422C157575B}" v="7" dt="2024-06-05T11:25:43.76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6980" autoAdjust="0"/>
    <p:restoredTop sz="94660"/>
  </p:normalViewPr>
  <p:slideViewPr>
    <p:cSldViewPr snapToGrid="0">
      <p:cViewPr varScale="1">
        <p:scale>
          <a:sx n="102" d="100"/>
          <a:sy n="102" d="100"/>
        </p:scale>
        <p:origin x="114" y="23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13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Ward Sents" userId="2248ff54-455c-479a-937e-c011824f6817" providerId="ADAL" clId="{9CB5B618-EFBB-43BC-8FE1-C422C157575B}"/>
    <pc:docChg chg="custSel addSld modSld">
      <pc:chgData name="Ward Sents" userId="2248ff54-455c-479a-937e-c011824f6817" providerId="ADAL" clId="{9CB5B618-EFBB-43BC-8FE1-C422C157575B}" dt="2024-06-05T11:25:49.161" v="75" actId="1076"/>
      <pc:docMkLst>
        <pc:docMk/>
      </pc:docMkLst>
      <pc:sldChg chg="modSp mod">
        <pc:chgData name="Ward Sents" userId="2248ff54-455c-479a-937e-c011824f6817" providerId="ADAL" clId="{9CB5B618-EFBB-43BC-8FE1-C422C157575B}" dt="2024-06-05T11:19:21.901" v="23" actId="20577"/>
        <pc:sldMkLst>
          <pc:docMk/>
          <pc:sldMk cId="948000180" sldId="256"/>
        </pc:sldMkLst>
        <pc:spChg chg="mod">
          <ac:chgData name="Ward Sents" userId="2248ff54-455c-479a-937e-c011824f6817" providerId="ADAL" clId="{9CB5B618-EFBB-43BC-8FE1-C422C157575B}" dt="2024-06-05T11:19:11.514" v="16" actId="20577"/>
          <ac:spMkLst>
            <pc:docMk/>
            <pc:sldMk cId="948000180" sldId="256"/>
            <ac:spMk id="2" creationId="{2E604531-1744-EF40-3EC3-420F91E45DD0}"/>
          </ac:spMkLst>
        </pc:spChg>
        <pc:spChg chg="mod">
          <ac:chgData name="Ward Sents" userId="2248ff54-455c-479a-937e-c011824f6817" providerId="ADAL" clId="{9CB5B618-EFBB-43BC-8FE1-C422C157575B}" dt="2024-06-05T11:19:21.901" v="23" actId="20577"/>
          <ac:spMkLst>
            <pc:docMk/>
            <pc:sldMk cId="948000180" sldId="256"/>
            <ac:spMk id="3" creationId="{7A5D18AF-F8B6-E0EB-CD98-D8064EC3AC4E}"/>
          </ac:spMkLst>
        </pc:spChg>
      </pc:sldChg>
      <pc:sldChg chg="addSp delSp modSp mod">
        <pc:chgData name="Ward Sents" userId="2248ff54-455c-479a-937e-c011824f6817" providerId="ADAL" clId="{9CB5B618-EFBB-43BC-8FE1-C422C157575B}" dt="2024-06-05T11:20:41.206" v="32" actId="14100"/>
        <pc:sldMkLst>
          <pc:docMk/>
          <pc:sldMk cId="2127406222" sldId="258"/>
        </pc:sldMkLst>
        <pc:spChg chg="add mod">
          <ac:chgData name="Ward Sents" userId="2248ff54-455c-479a-937e-c011824f6817" providerId="ADAL" clId="{9CB5B618-EFBB-43BC-8FE1-C422C157575B}" dt="2024-06-05T11:20:17.744" v="29" actId="1076"/>
          <ac:spMkLst>
            <pc:docMk/>
            <pc:sldMk cId="2127406222" sldId="258"/>
            <ac:spMk id="4" creationId="{D65247FF-823A-2960-05EA-6E1967464815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7" creationId="{17B0731B-6293-D109-AD73-CED11B1CE295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9" creationId="{57476341-A645-5C63-120F-1F298A4CDD66}"/>
          </ac:spMkLst>
        </pc:spChg>
        <pc:spChg chg="mod">
          <ac:chgData name="Ward Sents" userId="2248ff54-455c-479a-937e-c011824f6817" providerId="ADAL" clId="{9CB5B618-EFBB-43BC-8FE1-C422C157575B}" dt="2024-06-05T11:20:41.206" v="32" actId="14100"/>
          <ac:spMkLst>
            <pc:docMk/>
            <pc:sldMk cId="2127406222" sldId="258"/>
            <ac:spMk id="10" creationId="{F10FBA13-8776-2DAB-BC8E-07163E22ACCC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1" creationId="{8ACE6593-999D-FD31-7865-9239100A9E73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2" creationId="{627B7A95-F8E9-27F1-0E86-892A9A0DF958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3" creationId="{4CB902A2-A2B5-11BD-B113-8B18D5120781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4" creationId="{39C65A30-F696-FACE-95F8-A4F456FEFB66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5" creationId="{0DC1BAA0-353D-D897-0784-C630A1BE7395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6" creationId="{876F22EA-9C83-9FF4-2C3B-413E1C6F9008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7" creationId="{AD14DF0C-F9D7-1C94-70ED-C7B5826A6EBA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8" creationId="{E77F7A3D-0C84-D0C2-C2DD-90148F9AA411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19" creationId="{4231CF2D-1C17-DAC7-36A8-DD30A26E430B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20" creationId="{468ECFCF-9CFC-49EF-DFF9-8C4B3DA03DAC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21" creationId="{E71D89A8-3B11-BD65-6503-5827ECDD0711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22" creationId="{3C6DCFF4-60A3-A339-574B-369E7A0314F1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23" creationId="{6C1BD872-64BD-3427-BF5D-36A2FCD58577}"/>
          </ac:spMkLst>
        </pc:spChg>
        <pc:spChg chg="mod">
          <ac:chgData name="Ward Sents" userId="2248ff54-455c-479a-937e-c011824f6817" providerId="ADAL" clId="{9CB5B618-EFBB-43BC-8FE1-C422C157575B}" dt="2024-06-05T11:20:31.772" v="31" actId="1076"/>
          <ac:spMkLst>
            <pc:docMk/>
            <pc:sldMk cId="2127406222" sldId="258"/>
            <ac:spMk id="24" creationId="{D2A07B4E-8361-1796-90DA-DF4614067C60}"/>
          </ac:spMkLst>
        </pc:spChg>
        <pc:picChg chg="del">
          <ac:chgData name="Ward Sents" userId="2248ff54-455c-479a-937e-c011824f6817" providerId="ADAL" clId="{9CB5B618-EFBB-43BC-8FE1-C422C157575B}" dt="2024-06-05T11:20:22.659" v="30" actId="478"/>
          <ac:picMkLst>
            <pc:docMk/>
            <pc:sldMk cId="2127406222" sldId="258"/>
            <ac:picMk id="2" creationId="{0A52DB96-E810-5C84-F69A-5CE365E39010}"/>
          </ac:picMkLst>
        </pc:picChg>
        <pc:cxnChg chg="mod">
          <ac:chgData name="Ward Sents" userId="2248ff54-455c-479a-937e-c011824f6817" providerId="ADAL" clId="{9CB5B618-EFBB-43BC-8FE1-C422C157575B}" dt="2024-06-05T11:20:41.206" v="32" actId="14100"/>
          <ac:cxnSpMkLst>
            <pc:docMk/>
            <pc:sldMk cId="2127406222" sldId="258"/>
            <ac:cxnSpMk id="8" creationId="{FC81FDC6-93BA-BD67-F539-CA67F5BCBF42}"/>
          </ac:cxnSpMkLst>
        </pc:cxnChg>
        <pc:cxnChg chg="mod">
          <ac:chgData name="Ward Sents" userId="2248ff54-455c-479a-937e-c011824f6817" providerId="ADAL" clId="{9CB5B618-EFBB-43BC-8FE1-C422C157575B}" dt="2024-06-05T11:20:41.206" v="32" actId="14100"/>
          <ac:cxnSpMkLst>
            <pc:docMk/>
            <pc:sldMk cId="2127406222" sldId="258"/>
            <ac:cxnSpMk id="26" creationId="{5582FD2C-D134-F526-FCBB-16C305348BD5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28" creationId="{2C1E0655-BF12-2701-C4D1-AE73A9CCC8C3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31" creationId="{1A665C6B-7BB5-E5E2-ADDE-901EAF6C65F0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36" creationId="{43FE73A0-6244-3412-DFD2-0F2A098C5BDD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39" creationId="{9CEA891A-1CE9-5F38-8226-2A671304301B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42" creationId="{191777B7-8C76-9A52-02CE-8AA57A39AFB1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45" creationId="{1E5A0616-2436-26F3-8D44-A91116C53D44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48" creationId="{DA2EC4C1-7B8E-79BC-77C2-6628F3E3F93A}"/>
          </ac:cxnSpMkLst>
        </pc:cxnChg>
        <pc:cxnChg chg="mod">
          <ac:chgData name="Ward Sents" userId="2248ff54-455c-479a-937e-c011824f6817" providerId="ADAL" clId="{9CB5B618-EFBB-43BC-8FE1-C422C157575B}" dt="2024-06-05T11:20:31.772" v="31" actId="1076"/>
          <ac:cxnSpMkLst>
            <pc:docMk/>
            <pc:sldMk cId="2127406222" sldId="258"/>
            <ac:cxnSpMk id="50" creationId="{8B0BB418-2E7B-95C5-DF85-4FCFF8CEF378}"/>
          </ac:cxnSpMkLst>
        </pc:cxnChg>
      </pc:sldChg>
      <pc:sldChg chg="addSp delSp modSp mod">
        <pc:chgData name="Ward Sents" userId="2248ff54-455c-479a-937e-c011824f6817" providerId="ADAL" clId="{9CB5B618-EFBB-43BC-8FE1-C422C157575B}" dt="2024-06-05T11:21:43.129" v="37" actId="1076"/>
        <pc:sldMkLst>
          <pc:docMk/>
          <pc:sldMk cId="2779943889" sldId="259"/>
        </pc:sldMkLst>
        <pc:spChg chg="add mod">
          <ac:chgData name="Ward Sents" userId="2248ff54-455c-479a-937e-c011824f6817" providerId="ADAL" clId="{9CB5B618-EFBB-43BC-8FE1-C422C157575B}" dt="2024-06-05T11:20:13.666" v="28" actId="1076"/>
          <ac:spMkLst>
            <pc:docMk/>
            <pc:sldMk cId="2779943889" sldId="259"/>
            <ac:spMk id="4" creationId="{DD8307FF-9C75-F48E-AB70-D2328E6E94C5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7" creationId="{17B0731B-6293-D109-AD73-CED11B1CE295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9" creationId="{57476341-A645-5C63-120F-1F298A4CDD66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0" creationId="{F10FBA13-8776-2DAB-BC8E-07163E22ACCC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1" creationId="{8ACE6593-999D-FD31-7865-9239100A9E73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2" creationId="{627B7A95-F8E9-27F1-0E86-892A9A0DF958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3" creationId="{4CB902A2-A2B5-11BD-B113-8B18D5120781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4" creationId="{39C65A30-F696-FACE-95F8-A4F456FEFB66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5" creationId="{0DC1BAA0-353D-D897-0784-C630A1BE7395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6" creationId="{876F22EA-9C83-9FF4-2C3B-413E1C6F9008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7" creationId="{AD14DF0C-F9D7-1C94-70ED-C7B5826A6EBA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8" creationId="{E77F7A3D-0C84-D0C2-C2DD-90148F9AA411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19" creationId="{4231CF2D-1C17-DAC7-36A8-DD30A26E430B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20" creationId="{468ECFCF-9CFC-49EF-DFF9-8C4B3DA03DAC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21" creationId="{E71D89A8-3B11-BD65-6503-5827ECDD0711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22" creationId="{3C6DCFF4-60A3-A339-574B-369E7A0314F1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23" creationId="{6C1BD872-64BD-3427-BF5D-36A2FCD58577}"/>
          </ac:spMkLst>
        </pc:spChg>
        <pc:spChg chg="del">
          <ac:chgData name="Ward Sents" userId="2248ff54-455c-479a-937e-c011824f6817" providerId="ADAL" clId="{9CB5B618-EFBB-43BC-8FE1-C422C157575B}" dt="2024-06-05T11:21:07.692" v="33" actId="478"/>
          <ac:spMkLst>
            <pc:docMk/>
            <pc:sldMk cId="2779943889" sldId="259"/>
            <ac:spMk id="24" creationId="{D2A07B4E-8361-1796-90DA-DF4614067C60}"/>
          </ac:spMkLst>
        </pc:spChg>
        <pc:picChg chg="del">
          <ac:chgData name="Ward Sents" userId="2248ff54-455c-479a-937e-c011824f6817" providerId="ADAL" clId="{9CB5B618-EFBB-43BC-8FE1-C422C157575B}" dt="2024-06-05T11:21:08.467" v="34" actId="478"/>
          <ac:picMkLst>
            <pc:docMk/>
            <pc:sldMk cId="2779943889" sldId="259"/>
            <ac:picMk id="2" creationId="{0A52DB96-E810-5C84-F69A-5CE365E39010}"/>
          </ac:picMkLst>
        </pc:picChg>
        <pc:picChg chg="add mod">
          <ac:chgData name="Ward Sents" userId="2248ff54-455c-479a-937e-c011824f6817" providerId="ADAL" clId="{9CB5B618-EFBB-43BC-8FE1-C422C157575B}" dt="2024-06-05T11:21:43.129" v="37" actId="1076"/>
          <ac:picMkLst>
            <pc:docMk/>
            <pc:sldMk cId="2779943889" sldId="259"/>
            <ac:picMk id="5" creationId="{12E2E67F-C27A-A1E4-B446-D75DFA69F505}"/>
          </ac:picMkLst>
        </pc:pic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8" creationId="{FC81FDC6-93BA-BD67-F539-CA67F5BCBF42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26" creationId="{5582FD2C-D134-F526-FCBB-16C305348BD5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28" creationId="{2C1E0655-BF12-2701-C4D1-AE73A9CCC8C3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31" creationId="{1A665C6B-7BB5-E5E2-ADDE-901EAF6C65F0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36" creationId="{43FE73A0-6244-3412-DFD2-0F2A098C5BDD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39" creationId="{9CEA891A-1CE9-5F38-8226-2A671304301B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42" creationId="{191777B7-8C76-9A52-02CE-8AA57A39AFB1}"/>
          </ac:cxnSpMkLst>
        </pc:cxnChg>
        <pc:cxnChg chg="del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45" creationId="{1E5A0616-2436-26F3-8D44-A91116C53D44}"/>
          </ac:cxnSpMkLst>
        </pc:cxnChg>
        <pc:cxnChg chg="del mod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48" creationId="{DA2EC4C1-7B8E-79BC-77C2-6628F3E3F93A}"/>
          </ac:cxnSpMkLst>
        </pc:cxnChg>
        <pc:cxnChg chg="del">
          <ac:chgData name="Ward Sents" userId="2248ff54-455c-479a-937e-c011824f6817" providerId="ADAL" clId="{9CB5B618-EFBB-43BC-8FE1-C422C157575B}" dt="2024-06-05T11:21:07.692" v="33" actId="478"/>
          <ac:cxnSpMkLst>
            <pc:docMk/>
            <pc:sldMk cId="2779943889" sldId="259"/>
            <ac:cxnSpMk id="50" creationId="{8B0BB418-2E7B-95C5-DF85-4FCFF8CEF378}"/>
          </ac:cxnSpMkLst>
        </pc:cxnChg>
      </pc:sldChg>
      <pc:sldChg chg="addSp delSp modSp new mod">
        <pc:chgData name="Ward Sents" userId="2248ff54-455c-479a-937e-c011824f6817" providerId="ADAL" clId="{9CB5B618-EFBB-43BC-8FE1-C422C157575B}" dt="2024-06-05T11:23:51.494" v="58"/>
        <pc:sldMkLst>
          <pc:docMk/>
          <pc:sldMk cId="2557161381" sldId="260"/>
        </pc:sldMkLst>
        <pc:spChg chg="del">
          <ac:chgData name="Ward Sents" userId="2248ff54-455c-479a-937e-c011824f6817" providerId="ADAL" clId="{9CB5B618-EFBB-43BC-8FE1-C422C157575B}" dt="2024-06-05T11:22:25.931" v="40" actId="478"/>
          <ac:spMkLst>
            <pc:docMk/>
            <pc:sldMk cId="2557161381" sldId="260"/>
            <ac:spMk id="2" creationId="{086CB1F6-548A-3662-C55D-E89793D11C54}"/>
          </ac:spMkLst>
        </pc:spChg>
        <pc:spChg chg="del">
          <ac:chgData name="Ward Sents" userId="2248ff54-455c-479a-937e-c011824f6817" providerId="ADAL" clId="{9CB5B618-EFBB-43BC-8FE1-C422C157575B}" dt="2024-06-05T11:22:27.529" v="41" actId="478"/>
          <ac:spMkLst>
            <pc:docMk/>
            <pc:sldMk cId="2557161381" sldId="260"/>
            <ac:spMk id="3" creationId="{E3A1F578-4F8B-28F0-0DCE-9DD274F6EC17}"/>
          </ac:spMkLst>
        </pc:spChg>
        <pc:spChg chg="add del mod">
          <ac:chgData name="Ward Sents" userId="2248ff54-455c-479a-937e-c011824f6817" providerId="ADAL" clId="{9CB5B618-EFBB-43BC-8FE1-C422C157575B}" dt="2024-06-05T11:22:57.783" v="47" actId="21"/>
          <ac:spMkLst>
            <pc:docMk/>
            <pc:sldMk cId="2557161381" sldId="260"/>
            <ac:spMk id="5" creationId="{71680A84-3A93-E9E6-BD76-58B3CC0F4778}"/>
          </ac:spMkLst>
        </pc:spChg>
        <pc:spChg chg="add mod">
          <ac:chgData name="Ward Sents" userId="2248ff54-455c-479a-937e-c011824f6817" providerId="ADAL" clId="{9CB5B618-EFBB-43BC-8FE1-C422C157575B}" dt="2024-06-05T11:22:44.346" v="44" actId="1076"/>
          <ac:spMkLst>
            <pc:docMk/>
            <pc:sldMk cId="2557161381" sldId="260"/>
            <ac:spMk id="7" creationId="{8D72CDE5-FDA3-ABF9-277D-C5C5CF5258F9}"/>
          </ac:spMkLst>
        </pc:spChg>
        <pc:picChg chg="add mod">
          <ac:chgData name="Ward Sents" userId="2248ff54-455c-479a-937e-c011824f6817" providerId="ADAL" clId="{9CB5B618-EFBB-43BC-8FE1-C422C157575B}" dt="2024-06-05T11:23:51.494" v="58"/>
          <ac:picMkLst>
            <pc:docMk/>
            <pc:sldMk cId="2557161381" sldId="260"/>
            <ac:picMk id="8" creationId="{9AF1EEB0-162D-497D-CDE0-462A0AAE8DEF}"/>
          </ac:picMkLst>
        </pc:picChg>
      </pc:sldChg>
      <pc:sldChg chg="addSp delSp modSp new mod">
        <pc:chgData name="Ward Sents" userId="2248ff54-455c-479a-937e-c011824f6817" providerId="ADAL" clId="{9CB5B618-EFBB-43BC-8FE1-C422C157575B}" dt="2024-06-05T11:24:12.121" v="61" actId="1076"/>
        <pc:sldMkLst>
          <pc:docMk/>
          <pc:sldMk cId="3744706777" sldId="261"/>
        </pc:sldMkLst>
        <pc:spChg chg="del">
          <ac:chgData name="Ward Sents" userId="2248ff54-455c-479a-937e-c011824f6817" providerId="ADAL" clId="{9CB5B618-EFBB-43BC-8FE1-C422C157575B}" dt="2024-06-05T11:23:05.908" v="50" actId="478"/>
          <ac:spMkLst>
            <pc:docMk/>
            <pc:sldMk cId="3744706777" sldId="261"/>
            <ac:spMk id="2" creationId="{DC27E681-166E-2CA1-A8AE-3713F1DF73C7}"/>
          </ac:spMkLst>
        </pc:spChg>
        <pc:spChg chg="del">
          <ac:chgData name="Ward Sents" userId="2248ff54-455c-479a-937e-c011824f6817" providerId="ADAL" clId="{9CB5B618-EFBB-43BC-8FE1-C422C157575B}" dt="2024-06-05T11:23:07.440" v="51" actId="478"/>
          <ac:spMkLst>
            <pc:docMk/>
            <pc:sldMk cId="3744706777" sldId="261"/>
            <ac:spMk id="3" creationId="{E87FD6FD-96F5-F740-3D33-AD94973A99AC}"/>
          </ac:spMkLst>
        </pc:spChg>
        <pc:spChg chg="add mod">
          <ac:chgData name="Ward Sents" userId="2248ff54-455c-479a-937e-c011824f6817" providerId="ADAL" clId="{9CB5B618-EFBB-43BC-8FE1-C422C157575B}" dt="2024-06-05T11:23:03.745" v="49" actId="1076"/>
          <ac:spMkLst>
            <pc:docMk/>
            <pc:sldMk cId="3744706777" sldId="261"/>
            <ac:spMk id="5" creationId="{71680A84-3A93-E9E6-BD76-58B3CC0F4778}"/>
          </ac:spMkLst>
        </pc:spChg>
        <pc:picChg chg="add del mod">
          <ac:chgData name="Ward Sents" userId="2248ff54-455c-479a-937e-c011824f6817" providerId="ADAL" clId="{9CB5B618-EFBB-43BC-8FE1-C422C157575B}" dt="2024-06-05T11:23:49.707" v="57" actId="21"/>
          <ac:picMkLst>
            <pc:docMk/>
            <pc:sldMk cId="3744706777" sldId="261"/>
            <ac:picMk id="4" creationId="{9AF1EEB0-162D-497D-CDE0-462A0AAE8DEF}"/>
          </ac:picMkLst>
        </pc:picChg>
        <pc:picChg chg="add mod">
          <ac:chgData name="Ward Sents" userId="2248ff54-455c-479a-937e-c011824f6817" providerId="ADAL" clId="{9CB5B618-EFBB-43BC-8FE1-C422C157575B}" dt="2024-06-05T11:24:12.121" v="61" actId="1076"/>
          <ac:picMkLst>
            <pc:docMk/>
            <pc:sldMk cId="3744706777" sldId="261"/>
            <ac:picMk id="6" creationId="{C287FF85-5C39-2624-5A0F-7C28401CCCD2}"/>
          </ac:picMkLst>
        </pc:picChg>
      </pc:sldChg>
      <pc:sldChg chg="addSp delSp modSp new mod">
        <pc:chgData name="Ward Sents" userId="2248ff54-455c-479a-937e-c011824f6817" providerId="ADAL" clId="{9CB5B618-EFBB-43BC-8FE1-C422C157575B}" dt="2024-06-05T11:25:49.161" v="75" actId="1076"/>
        <pc:sldMkLst>
          <pc:docMk/>
          <pc:sldMk cId="2703158698" sldId="262"/>
        </pc:sldMkLst>
        <pc:spChg chg="del">
          <ac:chgData name="Ward Sents" userId="2248ff54-455c-479a-937e-c011824f6817" providerId="ADAL" clId="{9CB5B618-EFBB-43BC-8FE1-C422C157575B}" dt="2024-06-05T11:25:02.917" v="66" actId="478"/>
          <ac:spMkLst>
            <pc:docMk/>
            <pc:sldMk cId="2703158698" sldId="262"/>
            <ac:spMk id="2" creationId="{49DD5298-BD07-4389-C07E-D852A4C4BEC2}"/>
          </ac:spMkLst>
        </pc:spChg>
        <pc:spChg chg="del">
          <ac:chgData name="Ward Sents" userId="2248ff54-455c-479a-937e-c011824f6817" providerId="ADAL" clId="{9CB5B618-EFBB-43BC-8FE1-C422C157575B}" dt="2024-06-05T11:25:02.344" v="65" actId="478"/>
          <ac:spMkLst>
            <pc:docMk/>
            <pc:sldMk cId="2703158698" sldId="262"/>
            <ac:spMk id="3" creationId="{5387F89C-B83B-1E0B-9D62-E3760382369C}"/>
          </ac:spMkLst>
        </pc:spChg>
        <pc:spChg chg="add mod">
          <ac:chgData name="Ward Sents" userId="2248ff54-455c-479a-937e-c011824f6817" providerId="ADAL" clId="{9CB5B618-EFBB-43BC-8FE1-C422C157575B}" dt="2024-06-05T11:25:08.577" v="68" actId="1076"/>
          <ac:spMkLst>
            <pc:docMk/>
            <pc:sldMk cId="2703158698" sldId="262"/>
            <ac:spMk id="5" creationId="{918B3A15-9AE9-5924-3F51-B05D331D63C3}"/>
          </ac:spMkLst>
        </pc:spChg>
        <pc:picChg chg="add del mod">
          <ac:chgData name="Ward Sents" userId="2248ff54-455c-479a-937e-c011824f6817" providerId="ADAL" clId="{9CB5B618-EFBB-43BC-8FE1-C422C157575B}" dt="2024-06-05T11:25:25.847" v="72" actId="478"/>
          <ac:picMkLst>
            <pc:docMk/>
            <pc:sldMk cId="2703158698" sldId="262"/>
            <ac:picMk id="6" creationId="{E5D56586-52B8-75EA-A756-2C2AF3667611}"/>
          </ac:picMkLst>
        </pc:picChg>
        <pc:picChg chg="add mod">
          <ac:chgData name="Ward Sents" userId="2248ff54-455c-479a-937e-c011824f6817" providerId="ADAL" clId="{9CB5B618-EFBB-43BC-8FE1-C422C157575B}" dt="2024-06-05T11:25:49.161" v="75" actId="1076"/>
          <ac:picMkLst>
            <pc:docMk/>
            <pc:sldMk cId="2703158698" sldId="262"/>
            <ac:picMk id="7" creationId="{10807847-FEAE-8036-59F5-AA9CBC75E70D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F1DFBB5-82DF-E145-0A6A-7DE5B3365AC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02A8197-991F-E291-A083-9D59B4B39A85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451BF45-C241-5812-77A6-45328181542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137B64-8A21-8ED2-C01D-081A94ED649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397E8EC-E0E2-37CF-C963-2F29E25601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5718520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347DF9F-3977-19E6-6AE1-AE7A4424686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D41A0CF-9A8E-DEE2-BED0-D35318F672D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6076BFB-FF6A-E302-12AE-5E75DFEF1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F3CAF6C-578E-D536-492D-0BB90201088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E80388-BA30-A452-CFA0-E09769A57C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00834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008CFF5-7BB4-12F6-1377-CE3A10DB6397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FE8BB03-4C38-BA5C-CEEC-F90DE953EB1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E4AD74F-58C5-6BBF-7DA2-4A6B5E4687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6CECF3A-281F-4069-D11D-16B6E61C9D2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C23FB9-91DA-6F24-FD44-599C1E7CAE3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8626086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DD7C68F-7E51-B9F7-B836-A7F97972063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EE46AB6-6F87-60C7-FCC3-8F6C4F14C25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B9ED1F2-CBC9-BBF4-E40F-A5145C6D256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6E1EB25-30E1-C7B4-FA64-17D1B0E99E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EB0B56F-D9B3-3937-54C8-2F36D7BEE5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512082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1C6426-2283-77A2-3A8A-07521CE7650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C24D916B-93A6-8297-798A-104291CAA62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2049EB9-60B8-7B8A-DF7E-380767CBDAF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DCA3FCC-A055-D983-7F31-F64034AA1FC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C86BB9-3A0F-1EEB-6D85-E166490794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587332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3DB04DF-7D99-983C-1A22-6082ECBE03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6C7D795-EF6A-1917-B1B5-0C4EC7D75689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5C6E153-B8C3-F308-8BFA-F4D5663DC3A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8DD0D43-E751-B3E5-698F-93D08AB365F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986C15B-7C9E-2CD8-E0F6-8C7EAEE6DBC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81D5FAD-38E2-3C5A-6449-74A6BC0B67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0402737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DC8584-B758-591E-4092-4389C83131B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D3EFB8-04DC-28C4-256F-3534EC3D13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9BBC5BA-A777-0096-F181-8D096CCCE0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52A12D46-F4D8-921E-A471-896EE25F6B7F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3EEE477-91EE-830C-405D-439694EF85E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F30C215-4221-DBF2-9EF9-40B0ABEEC8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44811B4-5F91-FD36-0657-446301B30F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155DF7-8D4B-F184-C4E5-960DD8CC9ED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84125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13CB33-7FA0-558B-37C2-84EA01759C0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6143B8B-DA76-A4B2-330C-30EC7667E6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070CFD1-61DC-ADDA-4334-930AEA280B8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1AE9F96-DD0A-AD22-546C-A70706429B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91919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D9CF60FD-0A41-3D25-79DF-EAAD2E351E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F24502C-8258-1613-170A-C6C8E471F3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1881E40-FE61-DF4A-D3CF-DB344EC8A9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787866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ECBE80-170B-CBFA-069E-B3596E1333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1018AD-A04D-5F4E-2E33-3E04350218C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61658D-B961-D488-FDB9-25A0753FB27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99EDBE6-AEF9-2735-9F5F-D232447886B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10B4E04-A0B8-94C6-AFEB-C36C1A3158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0A2A781-B733-7F95-5F3F-3AC7FECF3F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5164563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405B8D1-D455-B9B7-9F48-50A80F5F65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B13399-68DD-DF9D-C96D-9C7BBCABF1F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E04240AB-3CA4-45B7-A18B-0937F4FD934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65FDA31-9BF0-776A-405D-F748981DA3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BC84196-CAD0-1664-977E-1956396BD4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FFDD3F-8BE9-FB5A-1299-F475AF540D0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447880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860352D-F96A-B130-FF93-400607F7388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7A00508-757E-49C1-A79E-02AECEFC36C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C783EA-BDE3-8C28-2EAE-897A5222EEA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BB5915BF-1BE5-4D39-B379-BE10137E7B62}" type="datetimeFigureOut">
              <a:rPr lang="en-GB" smtClean="0"/>
              <a:t>05/06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B73845D-2E2C-C1ED-E264-D1F94BD59E4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D1543B-9757-FE96-2E7B-1BED3668B5F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D688A92-7079-4F23-A631-80CDBEA07E6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3731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E604531-1744-EF40-3EC3-420F91E45DD0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GB" sz="2400" dirty="0"/>
              <a:t>Safety and efficacy of </a:t>
            </a:r>
            <a:r>
              <a:rPr lang="en-GB" sz="2400" dirty="0" err="1"/>
              <a:t>nintedanib</a:t>
            </a:r>
            <a:r>
              <a:rPr lang="en-GB" sz="2400" dirty="0"/>
              <a:t> as second-line therapy for</a:t>
            </a:r>
            <a:br>
              <a:rPr lang="en-GB" sz="2400" dirty="0"/>
            </a:br>
            <a:r>
              <a:rPr lang="en-GB" sz="2400" dirty="0"/>
              <a:t>patients with differentiated or medullary thyroid cancer</a:t>
            </a:r>
            <a:br>
              <a:rPr lang="en-GB" sz="2400" dirty="0"/>
            </a:br>
            <a:r>
              <a:rPr lang="en-GB" sz="2400" dirty="0"/>
              <a:t>progressing after first-line therapy. A randomized phase II</a:t>
            </a:r>
            <a:br>
              <a:rPr lang="en-GB" sz="2400" dirty="0"/>
            </a:br>
            <a:r>
              <a:rPr lang="en-GB" sz="2400" dirty="0"/>
              <a:t>study of the EORTC Endocrine Task Force (protocol 1209-EnTF)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A5D18AF-F8B6-E0EB-CD98-D8064EC3AC4E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GB" dirty="0"/>
              <a:t>Figures</a:t>
            </a:r>
          </a:p>
        </p:txBody>
      </p:sp>
    </p:spTree>
    <p:extLst>
      <p:ext uri="{BB962C8B-B14F-4D97-AF65-F5344CB8AC3E}">
        <p14:creationId xmlns:p14="http://schemas.microsoft.com/office/powerpoint/2010/main" val="94800018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: Rounded Corners 6">
            <a:extLst>
              <a:ext uri="{FF2B5EF4-FFF2-40B4-BE49-F238E27FC236}">
                <a16:creationId xmlns:a16="http://schemas.microsoft.com/office/drawing/2014/main" id="{17B0731B-6293-D109-AD73-CED11B1CE295}"/>
              </a:ext>
            </a:extLst>
          </p:cNvPr>
          <p:cNvSpPr/>
          <p:nvPr/>
        </p:nvSpPr>
        <p:spPr>
          <a:xfrm>
            <a:off x="3915182" y="1160935"/>
            <a:ext cx="1079954" cy="332221"/>
          </a:xfrm>
          <a:prstGeom prst="roundRect">
            <a:avLst/>
          </a:prstGeom>
          <a:solidFill>
            <a:srgbClr val="A9C7F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200" b="1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rollment</a:t>
            </a:r>
            <a:endParaRPr lang="en-GB" sz="14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57476341-A645-5C63-120F-1F298A4CDD66}"/>
              </a:ext>
            </a:extLst>
          </p:cNvPr>
          <p:cNvSpPr txBox="1"/>
          <p:nvPr/>
        </p:nvSpPr>
        <p:spPr>
          <a:xfrm>
            <a:off x="5302533" y="1089254"/>
            <a:ext cx="883960" cy="276999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200" dirty="0"/>
              <a:t>70 patient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F10FBA13-8776-2DAB-BC8E-07163E22ACCC}"/>
              </a:ext>
            </a:extLst>
          </p:cNvPr>
          <p:cNvSpPr txBox="1"/>
          <p:nvPr/>
        </p:nvSpPr>
        <p:spPr>
          <a:xfrm>
            <a:off x="5266340" y="1630979"/>
            <a:ext cx="1049402" cy="230832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900" dirty="0"/>
              <a:t>Randomized 2:1</a:t>
            </a:r>
          </a:p>
        </p:txBody>
      </p:sp>
      <p:sp>
        <p:nvSpPr>
          <p:cNvPr id="11" name="Rectangle: Rounded Corners 10">
            <a:extLst>
              <a:ext uri="{FF2B5EF4-FFF2-40B4-BE49-F238E27FC236}">
                <a16:creationId xmlns:a16="http://schemas.microsoft.com/office/drawing/2014/main" id="{8ACE6593-999D-FD31-7865-9239100A9E73}"/>
              </a:ext>
            </a:extLst>
          </p:cNvPr>
          <p:cNvSpPr/>
          <p:nvPr/>
        </p:nvSpPr>
        <p:spPr>
          <a:xfrm>
            <a:off x="5338486" y="2048391"/>
            <a:ext cx="812051" cy="230832"/>
          </a:xfrm>
          <a:prstGeom prst="roundRect">
            <a:avLst/>
          </a:prstGeom>
          <a:solidFill>
            <a:srgbClr val="A9C7F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location</a:t>
            </a:r>
            <a:endParaRPr lang="en-GB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627B7A95-F8E9-27F1-0E86-892A9A0DF958}"/>
              </a:ext>
            </a:extLst>
          </p:cNvPr>
          <p:cNvSpPr txBox="1"/>
          <p:nvPr/>
        </p:nvSpPr>
        <p:spPr>
          <a:xfrm>
            <a:off x="3990805" y="2511393"/>
            <a:ext cx="1612942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100" dirty="0"/>
              <a:t>45 patients in </a:t>
            </a:r>
            <a:r>
              <a:rPr lang="en-GB" sz="1100" dirty="0" err="1"/>
              <a:t>nintedanib</a:t>
            </a:r>
            <a:endParaRPr lang="en-GB" sz="1100" dirty="0"/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4CB902A2-A2B5-11BD-B113-8B18D5120781}"/>
              </a:ext>
            </a:extLst>
          </p:cNvPr>
          <p:cNvSpPr txBox="1"/>
          <p:nvPr/>
        </p:nvSpPr>
        <p:spPr>
          <a:xfrm>
            <a:off x="6070799" y="2511393"/>
            <a:ext cx="1446230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100" dirty="0"/>
              <a:t>25 patients in placebo</a:t>
            </a:r>
          </a:p>
        </p:txBody>
      </p:sp>
      <p:sp>
        <p:nvSpPr>
          <p:cNvPr id="14" name="Rectangle: Rounded Corners 13">
            <a:extLst>
              <a:ext uri="{FF2B5EF4-FFF2-40B4-BE49-F238E27FC236}">
                <a16:creationId xmlns:a16="http://schemas.microsoft.com/office/drawing/2014/main" id="{39C65A30-F696-FACE-95F8-A4F456FEFB66}"/>
              </a:ext>
            </a:extLst>
          </p:cNvPr>
          <p:cNvSpPr/>
          <p:nvPr/>
        </p:nvSpPr>
        <p:spPr>
          <a:xfrm>
            <a:off x="5054543" y="2827024"/>
            <a:ext cx="1487066" cy="230832"/>
          </a:xfrm>
          <a:prstGeom prst="roundRect">
            <a:avLst/>
          </a:prstGeom>
          <a:solidFill>
            <a:srgbClr val="A9C7F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ITT Population, n=70</a:t>
            </a:r>
            <a:endParaRPr lang="en-GB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Rectangle: Rounded Corners 14">
            <a:extLst>
              <a:ext uri="{FF2B5EF4-FFF2-40B4-BE49-F238E27FC236}">
                <a16:creationId xmlns:a16="http://schemas.microsoft.com/office/drawing/2014/main" id="{0DC1BAA0-353D-D897-0784-C630A1BE7395}"/>
              </a:ext>
            </a:extLst>
          </p:cNvPr>
          <p:cNvSpPr/>
          <p:nvPr/>
        </p:nvSpPr>
        <p:spPr>
          <a:xfrm>
            <a:off x="5338485" y="4232589"/>
            <a:ext cx="812051" cy="230832"/>
          </a:xfrm>
          <a:prstGeom prst="roundRect">
            <a:avLst/>
          </a:prstGeom>
          <a:solidFill>
            <a:srgbClr val="A9C7F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sis</a:t>
            </a:r>
            <a:endParaRPr lang="en-GB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Rectangle: Rounded Corners 15">
            <a:extLst>
              <a:ext uri="{FF2B5EF4-FFF2-40B4-BE49-F238E27FC236}">
                <a16:creationId xmlns:a16="http://schemas.microsoft.com/office/drawing/2014/main" id="{876F22EA-9C83-9FF4-2C3B-413E1C6F9008}"/>
              </a:ext>
            </a:extLst>
          </p:cNvPr>
          <p:cNvSpPr/>
          <p:nvPr/>
        </p:nvSpPr>
        <p:spPr>
          <a:xfrm>
            <a:off x="4741997" y="5209307"/>
            <a:ext cx="2009885" cy="218122"/>
          </a:xfrm>
          <a:prstGeom prst="roundRect">
            <a:avLst/>
          </a:prstGeom>
          <a:solidFill>
            <a:srgbClr val="A9C7F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er protocol Population, n=56</a:t>
            </a:r>
            <a:endParaRPr lang="en-GB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Rectangle: Rounded Corners 16">
            <a:extLst>
              <a:ext uri="{FF2B5EF4-FFF2-40B4-BE49-F238E27FC236}">
                <a16:creationId xmlns:a16="http://schemas.microsoft.com/office/drawing/2014/main" id="{AD14DF0C-F9D7-1C94-70ED-C7B5826A6EBA}"/>
              </a:ext>
            </a:extLst>
          </p:cNvPr>
          <p:cNvSpPr/>
          <p:nvPr/>
        </p:nvSpPr>
        <p:spPr>
          <a:xfrm>
            <a:off x="4835507" y="3462143"/>
            <a:ext cx="1818008" cy="230832"/>
          </a:xfrm>
          <a:prstGeom prst="roundRect">
            <a:avLst/>
          </a:prstGeom>
          <a:solidFill>
            <a:srgbClr val="A9C7FD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GB" sz="1050" b="1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afety Population, n=69</a:t>
            </a:r>
            <a:endParaRPr lang="en-GB" sz="1100" b="1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77F7A3D-0C84-D0C2-C2DD-90148F9AA411}"/>
              </a:ext>
            </a:extLst>
          </p:cNvPr>
          <p:cNvSpPr txBox="1"/>
          <p:nvPr/>
        </p:nvSpPr>
        <p:spPr>
          <a:xfrm>
            <a:off x="3713326" y="2836177"/>
            <a:ext cx="105349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800" dirty="0"/>
              <a:t>Early death 1 patient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4231CF2D-1C17-DAC7-36A8-DD30A26E430B}"/>
              </a:ext>
            </a:extLst>
          </p:cNvPr>
          <p:cNvSpPr txBox="1"/>
          <p:nvPr/>
        </p:nvSpPr>
        <p:spPr>
          <a:xfrm>
            <a:off x="4104618" y="3126077"/>
            <a:ext cx="138531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100" dirty="0"/>
              <a:t>44 started treatmen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468ECFCF-9CFC-49EF-DFF9-8C4B3DA03DAC}"/>
              </a:ext>
            </a:extLst>
          </p:cNvPr>
          <p:cNvSpPr txBox="1"/>
          <p:nvPr/>
        </p:nvSpPr>
        <p:spPr>
          <a:xfrm>
            <a:off x="6101256" y="3125056"/>
            <a:ext cx="1385316" cy="261610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1100" dirty="0"/>
              <a:t>25 started treatment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E71D89A8-3B11-BD65-6503-5827ECDD0711}"/>
              </a:ext>
            </a:extLst>
          </p:cNvPr>
          <p:cNvSpPr txBox="1"/>
          <p:nvPr/>
        </p:nvSpPr>
        <p:spPr>
          <a:xfrm>
            <a:off x="4102277" y="4536282"/>
            <a:ext cx="1387657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/>
              <a:t>37 patients' data used for analysis of primary end point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3C6DCFF4-60A3-A339-574B-369E7A0314F1}"/>
              </a:ext>
            </a:extLst>
          </p:cNvPr>
          <p:cNvSpPr txBox="1"/>
          <p:nvPr/>
        </p:nvSpPr>
        <p:spPr>
          <a:xfrm>
            <a:off x="6098915" y="4536282"/>
            <a:ext cx="1387657" cy="60016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GB" sz="1100" dirty="0"/>
              <a:t>19 patients' data used for analysis of primary end point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6C1BD872-64BD-3427-BF5D-36A2FCD58577}"/>
              </a:ext>
            </a:extLst>
          </p:cNvPr>
          <p:cNvSpPr txBox="1"/>
          <p:nvPr/>
        </p:nvSpPr>
        <p:spPr>
          <a:xfrm>
            <a:off x="3168076" y="3615441"/>
            <a:ext cx="1146468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Treatment arm </a:t>
            </a:r>
          </a:p>
          <a:p>
            <a:r>
              <a:rPr lang="en-GB" sz="800" dirty="0"/>
              <a:t>Ineligible=7</a:t>
            </a:r>
          </a:p>
          <a:p>
            <a:r>
              <a:rPr lang="en-GB" sz="800" dirty="0"/>
              <a:t>2 Brain metastasis</a:t>
            </a:r>
          </a:p>
          <a:p>
            <a:r>
              <a:rPr lang="en-GB" sz="800" dirty="0"/>
              <a:t>1 Pulmonary embolism</a:t>
            </a:r>
          </a:p>
          <a:p>
            <a:r>
              <a:rPr lang="en-GB" sz="800" dirty="0"/>
              <a:t>1 Lab value</a:t>
            </a:r>
          </a:p>
          <a:p>
            <a:r>
              <a:rPr lang="en-GB" sz="800" dirty="0"/>
              <a:t>3 other reasons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D2A07B4E-8361-1796-90DA-DF4614067C60}"/>
              </a:ext>
            </a:extLst>
          </p:cNvPr>
          <p:cNvSpPr txBox="1"/>
          <p:nvPr/>
        </p:nvSpPr>
        <p:spPr>
          <a:xfrm>
            <a:off x="7295723" y="3535630"/>
            <a:ext cx="1813317" cy="83099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none" rtlCol="0">
            <a:spAutoFit/>
          </a:bodyPr>
          <a:lstStyle/>
          <a:p>
            <a:r>
              <a:rPr lang="en-GB" sz="800" dirty="0"/>
              <a:t>Ineligible=6</a:t>
            </a:r>
          </a:p>
          <a:p>
            <a:r>
              <a:rPr lang="en-GB" sz="800" dirty="0"/>
              <a:t>2 Ongoing toxicity</a:t>
            </a:r>
          </a:p>
          <a:p>
            <a:r>
              <a:rPr lang="en-GB" sz="800" dirty="0"/>
              <a:t>1 Cardiac disease</a:t>
            </a:r>
          </a:p>
          <a:p>
            <a:r>
              <a:rPr lang="en-GB" sz="800" dirty="0"/>
              <a:t>1 Lab value</a:t>
            </a:r>
          </a:p>
          <a:p>
            <a:r>
              <a:rPr lang="en-GB" sz="800" dirty="0"/>
              <a:t>1 off treatment &lt; 4weeks prior random</a:t>
            </a:r>
          </a:p>
          <a:p>
            <a:r>
              <a:rPr lang="en-GB" sz="800" dirty="0"/>
              <a:t>1 DTC corrected to MTC</a:t>
            </a:r>
          </a:p>
        </p:txBody>
      </p: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FC81FDC6-93BA-BD67-F539-CA67F5BCBF42}"/>
              </a:ext>
            </a:extLst>
          </p:cNvPr>
          <p:cNvCxnSpPr>
            <a:cxnSpLocks/>
            <a:stCxn id="9" idx="2"/>
            <a:endCxn id="10" idx="0"/>
          </p:cNvCxnSpPr>
          <p:nvPr/>
        </p:nvCxnSpPr>
        <p:spPr>
          <a:xfrm>
            <a:off x="5744513" y="1366253"/>
            <a:ext cx="46528" cy="26472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Straight Connector 25">
            <a:extLst>
              <a:ext uri="{FF2B5EF4-FFF2-40B4-BE49-F238E27FC236}">
                <a16:creationId xmlns:a16="http://schemas.microsoft.com/office/drawing/2014/main" id="{5582FD2C-D134-F526-FCBB-16C305348BD5}"/>
              </a:ext>
            </a:extLst>
          </p:cNvPr>
          <p:cNvCxnSpPr>
            <a:cxnSpLocks/>
            <a:stCxn id="10" idx="2"/>
            <a:endCxn id="11" idx="0"/>
          </p:cNvCxnSpPr>
          <p:nvPr/>
        </p:nvCxnSpPr>
        <p:spPr>
          <a:xfrm flipH="1">
            <a:off x="5744512" y="1861811"/>
            <a:ext cx="46529" cy="18658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Connector: Elbow 27">
            <a:extLst>
              <a:ext uri="{FF2B5EF4-FFF2-40B4-BE49-F238E27FC236}">
                <a16:creationId xmlns:a16="http://schemas.microsoft.com/office/drawing/2014/main" id="{2C1E0655-BF12-2701-C4D1-AE73A9CCC8C3}"/>
              </a:ext>
            </a:extLst>
          </p:cNvPr>
          <p:cNvCxnSpPr>
            <a:cxnSpLocks/>
            <a:stCxn id="11" idx="2"/>
            <a:endCxn id="12" idx="0"/>
          </p:cNvCxnSpPr>
          <p:nvPr/>
        </p:nvCxnSpPr>
        <p:spPr>
          <a:xfrm rot="5400000">
            <a:off x="5154809" y="1921690"/>
            <a:ext cx="232170" cy="947236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or: Elbow 30">
            <a:extLst>
              <a:ext uri="{FF2B5EF4-FFF2-40B4-BE49-F238E27FC236}">
                <a16:creationId xmlns:a16="http://schemas.microsoft.com/office/drawing/2014/main" id="{1A665C6B-7BB5-E5E2-ADDE-901EAF6C65F0}"/>
              </a:ext>
            </a:extLst>
          </p:cNvPr>
          <p:cNvCxnSpPr>
            <a:cxnSpLocks/>
            <a:stCxn id="11" idx="2"/>
            <a:endCxn id="13" idx="0"/>
          </p:cNvCxnSpPr>
          <p:nvPr/>
        </p:nvCxnSpPr>
        <p:spPr>
          <a:xfrm rot="16200000" flipH="1">
            <a:off x="6153128" y="1870607"/>
            <a:ext cx="232170" cy="1049402"/>
          </a:xfrm>
          <a:prstGeom prst="bentConnector3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6" name="Straight Connector 35">
            <a:extLst>
              <a:ext uri="{FF2B5EF4-FFF2-40B4-BE49-F238E27FC236}">
                <a16:creationId xmlns:a16="http://schemas.microsoft.com/office/drawing/2014/main" id="{43FE73A0-6244-3412-DFD2-0F2A098C5BDD}"/>
              </a:ext>
            </a:extLst>
          </p:cNvPr>
          <p:cNvCxnSpPr>
            <a:cxnSpLocks/>
            <a:stCxn id="12" idx="2"/>
            <a:endCxn id="19" idx="0"/>
          </p:cNvCxnSpPr>
          <p:nvPr/>
        </p:nvCxnSpPr>
        <p:spPr>
          <a:xfrm>
            <a:off x="4797276" y="2773003"/>
            <a:ext cx="0" cy="353074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>
            <a:extLst>
              <a:ext uri="{FF2B5EF4-FFF2-40B4-BE49-F238E27FC236}">
                <a16:creationId xmlns:a16="http://schemas.microsoft.com/office/drawing/2014/main" id="{9CEA891A-1CE9-5F38-8226-2A671304301B}"/>
              </a:ext>
            </a:extLst>
          </p:cNvPr>
          <p:cNvCxnSpPr>
            <a:cxnSpLocks/>
            <a:stCxn id="13" idx="2"/>
            <a:endCxn id="20" idx="0"/>
          </p:cNvCxnSpPr>
          <p:nvPr/>
        </p:nvCxnSpPr>
        <p:spPr>
          <a:xfrm>
            <a:off x="6793914" y="2773003"/>
            <a:ext cx="0" cy="352053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Straight Connector 41">
            <a:extLst>
              <a:ext uri="{FF2B5EF4-FFF2-40B4-BE49-F238E27FC236}">
                <a16:creationId xmlns:a16="http://schemas.microsoft.com/office/drawing/2014/main" id="{191777B7-8C76-9A52-02CE-8AA57A39AFB1}"/>
              </a:ext>
            </a:extLst>
          </p:cNvPr>
          <p:cNvCxnSpPr>
            <a:cxnSpLocks/>
            <a:stCxn id="19" idx="2"/>
            <a:endCxn id="21" idx="0"/>
          </p:cNvCxnSpPr>
          <p:nvPr/>
        </p:nvCxnSpPr>
        <p:spPr>
          <a:xfrm flipH="1">
            <a:off x="4796106" y="3387687"/>
            <a:ext cx="1170" cy="1148595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5" name="Straight Arrow Connector 44">
            <a:extLst>
              <a:ext uri="{FF2B5EF4-FFF2-40B4-BE49-F238E27FC236}">
                <a16:creationId xmlns:a16="http://schemas.microsoft.com/office/drawing/2014/main" id="{1E5A0616-2436-26F3-8D44-A91116C53D44}"/>
              </a:ext>
            </a:extLst>
          </p:cNvPr>
          <p:cNvCxnSpPr>
            <a:cxnSpLocks/>
          </p:cNvCxnSpPr>
          <p:nvPr/>
        </p:nvCxnSpPr>
        <p:spPr>
          <a:xfrm flipH="1">
            <a:off x="4359192" y="3961984"/>
            <a:ext cx="436913" cy="740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8" name="Straight Connector 47">
            <a:extLst>
              <a:ext uri="{FF2B5EF4-FFF2-40B4-BE49-F238E27FC236}">
                <a16:creationId xmlns:a16="http://schemas.microsoft.com/office/drawing/2014/main" id="{DA2EC4C1-7B8E-79BC-77C2-6628F3E3F93A}"/>
              </a:ext>
            </a:extLst>
          </p:cNvPr>
          <p:cNvCxnSpPr>
            <a:cxnSpLocks/>
            <a:stCxn id="20" idx="2"/>
            <a:endCxn id="22" idx="0"/>
          </p:cNvCxnSpPr>
          <p:nvPr/>
        </p:nvCxnSpPr>
        <p:spPr>
          <a:xfrm flipH="1">
            <a:off x="6792744" y="3386666"/>
            <a:ext cx="1170" cy="1149616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0" name="Straight Arrow Connector 49">
            <a:extLst>
              <a:ext uri="{FF2B5EF4-FFF2-40B4-BE49-F238E27FC236}">
                <a16:creationId xmlns:a16="http://schemas.microsoft.com/office/drawing/2014/main" id="{8B0BB418-2E7B-95C5-DF85-4FCFF8CEF378}"/>
              </a:ext>
            </a:extLst>
          </p:cNvPr>
          <p:cNvCxnSpPr>
            <a:cxnSpLocks/>
          </p:cNvCxnSpPr>
          <p:nvPr/>
        </p:nvCxnSpPr>
        <p:spPr>
          <a:xfrm flipV="1">
            <a:off x="6792743" y="3968363"/>
            <a:ext cx="456639" cy="3456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" name="TextBox 3">
            <a:extLst>
              <a:ext uri="{FF2B5EF4-FFF2-40B4-BE49-F238E27FC236}">
                <a16:creationId xmlns:a16="http://schemas.microsoft.com/office/drawing/2014/main" id="{D65247FF-823A-2960-05EA-6E1967464815}"/>
              </a:ext>
            </a:extLst>
          </p:cNvPr>
          <p:cNvSpPr txBox="1"/>
          <p:nvPr/>
        </p:nvSpPr>
        <p:spPr>
          <a:xfrm>
            <a:off x="114158" y="147493"/>
            <a:ext cx="61078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(A) CONSORT flowchart: RAIR DTC cohort. </a:t>
            </a:r>
          </a:p>
        </p:txBody>
      </p:sp>
    </p:spTree>
    <p:extLst>
      <p:ext uri="{BB962C8B-B14F-4D97-AF65-F5344CB8AC3E}">
        <p14:creationId xmlns:p14="http://schemas.microsoft.com/office/powerpoint/2010/main" val="212740622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DD8307FF-9C75-F48E-AB70-D2328E6E94C5}"/>
              </a:ext>
            </a:extLst>
          </p:cNvPr>
          <p:cNvSpPr txBox="1"/>
          <p:nvPr/>
        </p:nvSpPr>
        <p:spPr>
          <a:xfrm>
            <a:off x="97655" y="147493"/>
            <a:ext cx="6107836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(B) CONSORT flowchart: MTC cohort.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12E2E67F-C27A-A1E4-B446-D75DFA69F50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76619" y="1012349"/>
            <a:ext cx="6638762" cy="483330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79943889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8D72CDE5-FDA3-ABF9-277D-C5C5CF5258F9}"/>
              </a:ext>
            </a:extLst>
          </p:cNvPr>
          <p:cNvSpPr txBox="1"/>
          <p:nvPr/>
        </p:nvSpPr>
        <p:spPr>
          <a:xfrm>
            <a:off x="224161" y="169545"/>
            <a:ext cx="6094520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Progression-free survival (PFS) in the RAIR DTC per-protocol population (A)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9AF1EEB0-162D-497D-CDE0-462A0AAE8DE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41543" y="986127"/>
            <a:ext cx="6716300" cy="503466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57161381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71680A84-3A93-E9E6-BD76-58B3CC0F4778}"/>
              </a:ext>
            </a:extLst>
          </p:cNvPr>
          <p:cNvSpPr txBox="1"/>
          <p:nvPr/>
        </p:nvSpPr>
        <p:spPr>
          <a:xfrm>
            <a:off x="286305" y="230188"/>
            <a:ext cx="609452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and in the intention-to-treat (ITT) population (B)</a:t>
            </a:r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C287FF85-5C39-2624-5A0F-7C28401CCCD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158739" y="1047874"/>
            <a:ext cx="6673288" cy="500988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4470677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>
            <a:extLst>
              <a:ext uri="{FF2B5EF4-FFF2-40B4-BE49-F238E27FC236}">
                <a16:creationId xmlns:a16="http://schemas.microsoft.com/office/drawing/2014/main" id="{918B3A15-9AE9-5924-3F51-B05D331D63C3}"/>
              </a:ext>
            </a:extLst>
          </p:cNvPr>
          <p:cNvSpPr txBox="1"/>
          <p:nvPr/>
        </p:nvSpPr>
        <p:spPr>
          <a:xfrm>
            <a:off x="184581" y="211108"/>
            <a:ext cx="11822837" cy="64633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dirty="0"/>
              <a:t>Frequency of clinical adverse events of the </a:t>
            </a:r>
            <a:r>
              <a:rPr lang="en-GB" dirty="0" err="1"/>
              <a:t>nintedanib</a:t>
            </a:r>
            <a:r>
              <a:rPr lang="en-GB" dirty="0"/>
              <a:t>-treated group compared to the placebo group during randomized treatment in both cohorts.</a:t>
            </a: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10807847-FEAE-8036-59F5-AA9CBC75E70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675863" y="857439"/>
            <a:ext cx="4840271" cy="580832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7031586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6792afc2-362e-403b-b394-f5ba78e99373}" enabled="0" method="" siteId="{6792afc2-362e-403b-b394-f5ba78e99373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12</Words>
  <Application>Microsoft Office PowerPoint</Application>
  <PresentationFormat>Widescreen</PresentationFormat>
  <Paragraphs>3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Office Theme</vt:lpstr>
      <vt:lpstr>Safety and efficacy of nintedanib as second-line therapy for patients with differentiated or medullary thyroid cancer progressing after first-line therapy. A randomized phase II study of the EORTC Endocrine Task Force (protocol 1209-EnTF)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rd Sents</dc:creator>
  <cp:lastModifiedBy>Ward Sents</cp:lastModifiedBy>
  <cp:revision>1</cp:revision>
  <dcterms:created xsi:type="dcterms:W3CDTF">2024-06-05T11:17:42Z</dcterms:created>
  <dcterms:modified xsi:type="dcterms:W3CDTF">2024-06-05T11:25:52Z</dcterms:modified>
</cp:coreProperties>
</file>